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8" r:id="rId2"/>
    <p:sldId id="269" r:id="rId3"/>
    <p:sldId id="309" r:id="rId4"/>
    <p:sldId id="310" r:id="rId5"/>
    <p:sldId id="307" r:id="rId6"/>
    <p:sldId id="267" r:id="rId7"/>
    <p:sldId id="285" r:id="rId8"/>
    <p:sldId id="286" r:id="rId9"/>
    <p:sldId id="304" r:id="rId10"/>
    <p:sldId id="305" r:id="rId11"/>
    <p:sldId id="300" r:id="rId12"/>
    <p:sldId id="290" r:id="rId13"/>
    <p:sldId id="258" r:id="rId14"/>
    <p:sldId id="306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9CFAE95-22F3-5228-A2CC-D488A6EE75A2}" name="Max Haggblom" initials="MH" userId="S::haggblom@sebs.rutgers.edu::bc5c299d-46f1-4d8b-abec-4f338583d0f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BFD5"/>
    <a:srgbClr val="FF7C80"/>
    <a:srgbClr val="FF5050"/>
    <a:srgbClr val="95B0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4B953E5-7BC4-41C8-982C-9B4033474E11}" v="1" dt="2026-02-23T17:21:27.73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99" autoAdjust="0"/>
    <p:restoredTop sz="94920" autoAdjust="0"/>
  </p:normalViewPr>
  <p:slideViewPr>
    <p:cSldViewPr snapToGrid="0" snapToObjects="1">
      <p:cViewPr varScale="1">
        <p:scale>
          <a:sx n="63" d="100"/>
          <a:sy n="63" d="100"/>
        </p:scale>
        <p:origin x="9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8/10/relationships/authors" Target="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CB7EC9-31E4-C84F-BACE-022B47535B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37C734-40C1-D548-A606-9E33B6DF2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04F04-CABB-9C4B-B977-4FBAFDC33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EAA71F-EEA0-E646-8E08-4D0CCC267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EA024-7A3A-3341-B147-8833E1F62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772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021BE-9771-2E4A-B49E-6827EBDDE9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E2C922-B7E4-0846-8A85-15E3698C3E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60ED69-F68B-C245-AD62-043469837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51B376-930F-7444-9BFF-5A0358AE9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C76F65-06DF-6B4E-8249-CD748061B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886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D8F227-11AC-BC4F-A520-05D4B53BF6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A0907F-7601-8F4B-B81A-9199AB7067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01920-CD7E-D744-B2A5-6584455B0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10480-6DF6-7141-9A42-B488AFA23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CA6E1A-3938-4746-8E3B-4BAB1C09A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965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90D77-38D4-9543-AC63-C7ADD5C674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6CAB35-2543-D24A-B4C4-1C29AB7056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F0A993-96BE-1741-9A01-01ED52452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6FF3DE-635B-D84B-85B7-CEA99B46D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FAE26-15E1-4D46-B64F-6362414ED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288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EB00E-845B-ED4E-9488-8750614A3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67A751-3516-C645-AD59-9D52FAEDA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AAE6EF-1E4C-EB45-89B5-C0C77247A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822F5-3CE0-8042-8012-A698228AF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902A68-2FEA-BE48-BAC0-7D5782C95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973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970F4-51C2-6140-A79F-376FB3F01D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6ADE22-1438-9547-ABC7-1D88375620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6F9306-32B4-7246-9842-EAFE135641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5F9A94-38BE-AF4B-AC1C-061971229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379C81-F582-DF40-88FB-594CBA7E8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036A6E-5DDF-3346-8553-B05840403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321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15F13-360D-6F41-BEA4-C2FC0B5A6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7F786E-3847-8841-821A-4633F45276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E37841-870C-5E47-981D-294C98E9B3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395B45-DDA7-1645-BAE2-AB16BF9C3F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4C02A4-3668-3941-8C43-3E7CDFBE9C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C99820-2EE6-194A-9F0B-F80107E2B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FC2E18-9BB7-AA4C-820F-632CBEE2B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5874A-CC83-EB4D-B08A-87D876E8B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616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48CBB-DCDD-094A-9A45-6F9CFAFCD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BC6188-E791-F241-8403-7619D073C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D8B2E6D-718D-D84B-B2B7-E8A3032B4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B4548E-01A1-6645-A001-63C984405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635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D9195B-5924-EA4A-8037-15B52C753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E525A4-D692-B04E-9CC2-C22E82C11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1BEF4D-B222-D34F-A868-862309336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18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70845D-E4A3-2E49-BB18-E71F47F95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290A21-98C3-9943-9512-F551FE02AE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C76AC6-52F3-ED43-AC68-161F322A1E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4171CD-BE77-E24F-B761-2FA213FDD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F862A4-B406-5541-8A8F-643259696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1EEBC2-4164-AF40-8CA8-26E00B4E0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885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BD9465-BD3A-0C45-9C6F-B44F41E6C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357105-5BAD-544D-B2E0-1E2ED991E5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BC550D-FEEB-2648-9863-5A1C198394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1FAE4B-4B8F-B643-B63D-A6A0DD9C6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E657EA-F14E-C146-A799-30E5D790D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FFC681-C0DE-6148-B5C9-80B61EC2C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71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B18CB2-3994-6B49-8427-6525B1C20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5AE497-3090-654F-A926-5A5796AC6D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CE30B0-A7FE-1943-BA76-97F4A930FB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187563-1155-3142-AEAA-E84809ADE689}" type="datetimeFigureOut">
              <a:rPr lang="en-US" smtClean="0"/>
              <a:t>2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61D610-43B6-3E4C-B22A-1FCDE6720B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C4EA6-807F-6841-8BC0-0A03361955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9A397-4D15-8E48-A570-12CA3C04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04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aracamp@kines.rutgers.edu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E96B3-53E2-A3F4-909C-D958533D41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2" y="212652"/>
            <a:ext cx="10515600" cy="5964312"/>
          </a:xfrm>
        </p:spPr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isruption of the Gut Microbiota in Regulator of G protein Signaling 14 Knockout (RGS14 KO) Mice Alters the Metabolome and Reduces Enhanced Exercise Capacity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Candace R. Longoria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Daniel D. DeSio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Marko Oydanich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Xiaoyang Su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Eric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Chiles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Lee J. Kerkhof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4,8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Olufunmilola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Ibironke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4,8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Max M. Häggblom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5,8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Nathan P. Wages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John J. Guers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Dorothy E. Vatner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Stephen F. Vatner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Sara C. Campbell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1,6,7,8*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Department of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Kinesiolog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Health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Department of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Biolog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&amp;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edicine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Rutgers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Universit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-New Jersey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edical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School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Newark, NJ, USA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Cancer Institute of NJ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etabolomics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Share Resource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Department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edicine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Department of Marine and Coastal Sciences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Department of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Biochemistr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icrobiolog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Institute for Food, Nutrition, and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Health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Center for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Research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Center for Human Nutrition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Exercise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Center for Nutrition, Microbiome, and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Health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Department of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Rehabilitation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Movement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Sciences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1,3,4,5,6,7,8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Rutgers, The State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Universit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of New Jersey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New Brunswick, NJ USA,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2,9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Rutgers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Universit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Newark, New Jersey, USA </a:t>
            </a:r>
            <a:r>
              <a:rPr lang="fr-FR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East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Stroudsburg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University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East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Stroudsburg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Pennsylvani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Denotes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author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Author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: 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Sara C. Campbell, PhD, FACSM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Lipman</a:t>
            </a: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 Drive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New Brunswick, NJ 0890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Rutgers </a:t>
            </a:r>
            <a:r>
              <a:rPr lang="fr-FR" sz="2400" dirty="0" err="1">
                <a:latin typeface="Arial" panose="020B0604020202020204" pitchFamily="34" charset="0"/>
                <a:cs typeface="Arial" panose="020B0604020202020204" pitchFamily="34" charset="0"/>
              </a:rPr>
              <a:t>UniversityFauthor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u="sng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saracamp@kines.rutgers.edu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fr-FR" sz="2400" dirty="0">
                <a:latin typeface="Arial" panose="020B0604020202020204" pitchFamily="34" charset="0"/>
                <a:cs typeface="Arial" panose="020B0604020202020204" pitchFamily="34" charset="0"/>
              </a:rPr>
              <a:t>848 932 7036</a:t>
            </a: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uropean Journal of Applied Physiology</a:t>
            </a:r>
          </a:p>
          <a:p>
            <a:pPr marL="0" indent="0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34358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87C9DF-7606-4536-302E-DFC905CD1D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E4E0773-1ADB-4F16-49C1-B06A91536D63}"/>
              </a:ext>
            </a:extLst>
          </p:cNvPr>
          <p:cNvSpPr txBox="1"/>
          <p:nvPr/>
        </p:nvSpPr>
        <p:spPr>
          <a:xfrm>
            <a:off x="636185" y="6362242"/>
            <a:ext cx="11555815" cy="264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8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 of the top 10 bacterial families in fecal samples of the RGS14 KO and WT mice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chart showing the number of individuals&#10;&#10;AI-generated content may be incorrect.">
            <a:extLst>
              <a:ext uri="{FF2B5EF4-FFF2-40B4-BE49-F238E27FC236}">
                <a16:creationId xmlns:a16="http://schemas.microsoft.com/office/drawing/2014/main" id="{AB5B029E-3E04-D7D7-8421-C2AD5ED596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0" y="747713"/>
            <a:ext cx="9753600" cy="5362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63184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F6274E-2EA8-146A-7F07-BAB7A23601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AF10B51-AADC-BD5F-A2D8-7D6F659D8DD9}"/>
              </a:ext>
            </a:extLst>
          </p:cNvPr>
          <p:cNvSpPr txBox="1"/>
          <p:nvPr/>
        </p:nvSpPr>
        <p:spPr>
          <a:xfrm>
            <a:off x="877301" y="6257543"/>
            <a:ext cx="9303934" cy="264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9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s of the top 50 matched bacterial strains matched to ribosomal RNA operon reads shown in a bubble plot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 descr="A diagram of different types of bacteria&#10;&#10;AI-generated content may be incorrect.">
            <a:extLst>
              <a:ext uri="{FF2B5EF4-FFF2-40B4-BE49-F238E27FC236}">
                <a16:creationId xmlns:a16="http://schemas.microsoft.com/office/drawing/2014/main" id="{7BB2D9B5-D20D-993A-07DD-8609466DBD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707" y="30904"/>
            <a:ext cx="8490112" cy="6226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43154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53FA09E7-924A-F583-9E32-5E18F7C91C69}"/>
              </a:ext>
            </a:extLst>
          </p:cNvPr>
          <p:cNvGrpSpPr/>
          <p:nvPr/>
        </p:nvGrpSpPr>
        <p:grpSpPr>
          <a:xfrm>
            <a:off x="1705973" y="393264"/>
            <a:ext cx="8377002" cy="5065844"/>
            <a:chOff x="1634247" y="242182"/>
            <a:chExt cx="9440400" cy="5681963"/>
          </a:xfrm>
        </p:grpSpPr>
        <p:pic>
          <p:nvPicPr>
            <p:cNvPr id="3" name="Picture 2" descr="A picture containing text, sky&#10;&#10;Description automatically generated">
              <a:extLst>
                <a:ext uri="{FF2B5EF4-FFF2-40B4-BE49-F238E27FC236}">
                  <a16:creationId xmlns:a16="http://schemas.microsoft.com/office/drawing/2014/main" id="{3C3C8CEE-C77C-954C-9FCE-3AC3F13B53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34247" y="580736"/>
              <a:ext cx="9440400" cy="5343409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125C0D8-3C75-3C4C-9958-A1D15EBBBBF1}"/>
                </a:ext>
              </a:extLst>
            </p:cNvPr>
            <p:cNvSpPr txBox="1"/>
            <p:nvPr/>
          </p:nvSpPr>
          <p:spPr>
            <a:xfrm>
              <a:off x="3087582" y="242182"/>
              <a:ext cx="7459368" cy="3797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mparison of Bacterial Genera between RGS14 KO and WT mice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559C6C8-A1BE-AAB5-B197-42A0700FD705}"/>
              </a:ext>
            </a:extLst>
          </p:cNvPr>
          <p:cNvSpPr txBox="1"/>
          <p:nvPr/>
        </p:nvSpPr>
        <p:spPr>
          <a:xfrm>
            <a:off x="1705970" y="5588244"/>
            <a:ext cx="9239534" cy="6233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 10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Non-metric multidimensional scaling (NMDS) ordination plots of Kulczynski distances based on bacterial strains of WT and RGS14 KO mice. Each point represents a fecal sample from a WT or RGS14 KO mouse. Significance values refer to permutational multivariate analysis of variance test for distance differences between WT and RGS14 KO</a:t>
            </a:r>
            <a:endParaRPr lang="en-US" sz="1100" b="1" dirty="0">
              <a:highlight>
                <a:srgbClr val="FFFF00"/>
              </a:highlight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42960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0C20293-CE11-2778-E927-F73A3E2FC8FF}"/>
              </a:ext>
            </a:extLst>
          </p:cNvPr>
          <p:cNvSpPr txBox="1"/>
          <p:nvPr/>
        </p:nvSpPr>
        <p:spPr>
          <a:xfrm>
            <a:off x="2302994" y="5286523"/>
            <a:ext cx="8406044" cy="6233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 11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Non-metric multidimensional scaling (NMDS) ordination plots of Kulczynski distances based on bacterial strains of WT and RGS14 KO mice. Each point represents a fecal sample from a WT or RGS14 KO mouse. Significance values refer to permutational multivariate analysis of variance test for distance differences between WT and RGS14 KO</a:t>
            </a:r>
            <a:endParaRPr lang="en-US" sz="1100" b="1" dirty="0">
              <a:highlight>
                <a:srgbClr val="FFFF00"/>
              </a:highlight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163235D-6E2A-8132-3B30-535588B2E303}"/>
              </a:ext>
            </a:extLst>
          </p:cNvPr>
          <p:cNvGrpSpPr/>
          <p:nvPr/>
        </p:nvGrpSpPr>
        <p:grpSpPr>
          <a:xfrm>
            <a:off x="2302995" y="352167"/>
            <a:ext cx="7586013" cy="4697509"/>
            <a:chOff x="2305455" y="305067"/>
            <a:chExt cx="8368141" cy="558165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FFB4149-E4EA-354D-96F4-72EF9E52287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05455" y="897850"/>
              <a:ext cx="8368141" cy="498887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59AA32E-76BD-9EEB-E992-2138F794D5B5}"/>
                </a:ext>
              </a:extLst>
            </p:cNvPr>
            <p:cNvSpPr txBox="1"/>
            <p:nvPr/>
          </p:nvSpPr>
          <p:spPr>
            <a:xfrm>
              <a:off x="3028087" y="305067"/>
              <a:ext cx="7375828" cy="4022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mparison of Bacterial Species between RGS14 KO and WT mic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511738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9E86948-3229-890E-7B41-76D86F0C14EA}"/>
              </a:ext>
            </a:extLst>
          </p:cNvPr>
          <p:cNvGrpSpPr/>
          <p:nvPr/>
        </p:nvGrpSpPr>
        <p:grpSpPr>
          <a:xfrm>
            <a:off x="3072771" y="93344"/>
            <a:ext cx="6135024" cy="6271249"/>
            <a:chOff x="-1" y="0"/>
            <a:chExt cx="6046968" cy="6671862"/>
          </a:xfrm>
        </p:grpSpPr>
        <p:sp>
          <p:nvSpPr>
            <p:cNvPr id="3" name="Text Box 2">
              <a:extLst>
                <a:ext uri="{FF2B5EF4-FFF2-40B4-BE49-F238E27FC236}">
                  <a16:creationId xmlns:a16="http://schemas.microsoft.com/office/drawing/2014/main" id="{286FA9D9-0C8B-AAF1-3AE7-4A24BFD99B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" y="0"/>
              <a:ext cx="4523331" cy="309024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1" rIns="91440" bIns="45721" anchor="t" anchorCtr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ea typeface="Times New Roman" panose="02020603050405020304" pitchFamily="18" charset="0"/>
                </a:rPr>
                <a:t>Supplementary Table 2. Strain-level DESeq2 Analysis</a:t>
              </a:r>
              <a:endParaRPr 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86F2794-A118-6520-7B7C-AF9634D08D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367" y="318052"/>
              <a:ext cx="5943600" cy="635381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5" name="Text Box 2">
            <a:extLst>
              <a:ext uri="{FF2B5EF4-FFF2-40B4-BE49-F238E27FC236}">
                <a16:creationId xmlns:a16="http://schemas.microsoft.com/office/drawing/2014/main" id="{84507ED9-9086-4AF2-E2A2-2E0F3AFCD2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8221" y="6364594"/>
            <a:ext cx="6879304" cy="26161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1" rIns="91440" bIns="45721" anchor="t" anchorCtr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. Table 2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Depleted and enriched bacterial strains in RGS14 KO mice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61280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7DBEB0C8-303A-EF4F-CE8B-A2D5F0155433}"/>
              </a:ext>
            </a:extLst>
          </p:cNvPr>
          <p:cNvGrpSpPr/>
          <p:nvPr/>
        </p:nvGrpSpPr>
        <p:grpSpPr>
          <a:xfrm>
            <a:off x="1685843" y="1812925"/>
            <a:ext cx="9788524" cy="3230564"/>
            <a:chOff x="1685838" y="1812925"/>
            <a:chExt cx="9788525" cy="3230563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04EC9948-5A44-4D1D-7D08-503C5CE5987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87831632"/>
                </p:ext>
              </p:extLst>
            </p:nvPr>
          </p:nvGraphicFramePr>
          <p:xfrm>
            <a:off x="1685838" y="1812925"/>
            <a:ext cx="9788525" cy="3230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9787768" imgH="3230582" progId="Prism10.Document">
                    <p:embed/>
                  </p:oleObj>
                </mc:Choice>
                <mc:Fallback>
                  <p:oleObj name="Prism 10" r:id="rId2" imgW="9787768" imgH="3230582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04EC9948-5A44-4D1D-7D08-503C5CE5987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685838" y="1812925"/>
                          <a:ext cx="9788525" cy="32305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DFC33DF-8BA6-7EB2-1742-CC716241AE84}"/>
                </a:ext>
              </a:extLst>
            </p:cNvPr>
            <p:cNvSpPr txBox="1"/>
            <p:nvPr/>
          </p:nvSpPr>
          <p:spPr>
            <a:xfrm>
              <a:off x="1884064" y="2021442"/>
              <a:ext cx="344032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9B16698-87B6-B1A3-F309-1EE452EF8A0F}"/>
                </a:ext>
              </a:extLst>
            </p:cNvPr>
            <p:cNvSpPr txBox="1"/>
            <p:nvPr/>
          </p:nvSpPr>
          <p:spPr>
            <a:xfrm>
              <a:off x="4700212" y="2021442"/>
              <a:ext cx="344032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F8FFD0E-72DF-AF17-7DD2-A8DC1D3E9B13}"/>
                </a:ext>
              </a:extLst>
            </p:cNvPr>
            <p:cNvSpPr txBox="1"/>
            <p:nvPr/>
          </p:nvSpPr>
          <p:spPr>
            <a:xfrm>
              <a:off x="7383659" y="2021442"/>
              <a:ext cx="344032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52E1EE1D-968E-4981-2AFB-3EF2FCB522AB}"/>
              </a:ext>
            </a:extLst>
          </p:cNvPr>
          <p:cNvSpPr txBox="1"/>
          <p:nvPr/>
        </p:nvSpPr>
        <p:spPr>
          <a:xfrm>
            <a:off x="855647" y="4720327"/>
            <a:ext cx="1086415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Fig. 1 Markers of mitochondrial biogenesis in skeletal muscle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RT1,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RT3,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MPK presented with no significant differences in pre-ABX or post-ABX groups for both RGS14 KO mice and their WTL. There was a significant effect of antibiotic treatment f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RT1 (p=0.0274)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MPK (p=0.0100), but not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RT3. Data shown as mean ± standard deviation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9219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88DDE79C-7884-BF00-71AA-448F85734CF1}"/>
              </a:ext>
            </a:extLst>
          </p:cNvPr>
          <p:cNvGrpSpPr/>
          <p:nvPr/>
        </p:nvGrpSpPr>
        <p:grpSpPr>
          <a:xfrm>
            <a:off x="485030" y="295736"/>
            <a:ext cx="4340872" cy="6002080"/>
            <a:chOff x="485030" y="295736"/>
            <a:chExt cx="4340872" cy="6002080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BF6092C7-EBE1-1EE0-5024-9AA07B6F2EDB}"/>
                </a:ext>
              </a:extLst>
            </p:cNvPr>
            <p:cNvGrpSpPr/>
            <p:nvPr/>
          </p:nvGrpSpPr>
          <p:grpSpPr>
            <a:xfrm>
              <a:off x="794478" y="295736"/>
              <a:ext cx="4031424" cy="6002080"/>
              <a:chOff x="794478" y="295736"/>
              <a:chExt cx="4031424" cy="6002080"/>
            </a:xfrm>
          </p:grpSpPr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5FF1312E-6FCE-764D-DB44-0068D93A0A7B}"/>
                  </a:ext>
                </a:extLst>
              </p:cNvPr>
              <p:cNvGrpSpPr/>
              <p:nvPr/>
            </p:nvGrpSpPr>
            <p:grpSpPr>
              <a:xfrm>
                <a:off x="794478" y="295736"/>
                <a:ext cx="4031424" cy="6002080"/>
                <a:chOff x="794478" y="295736"/>
                <a:chExt cx="4031424" cy="6002080"/>
              </a:xfrm>
            </p:grpSpPr>
            <p:pic>
              <p:nvPicPr>
                <p:cNvPr id="8" name="Picture 7" descr="A screenshot of a graph&#10;&#10;AI-generated content may be incorrect.">
                  <a:extLst>
                    <a:ext uri="{FF2B5EF4-FFF2-40B4-BE49-F238E27FC236}">
                      <a16:creationId xmlns:a16="http://schemas.microsoft.com/office/drawing/2014/main" id="{A1A9FC7D-AEF6-BA50-513B-55E88740AE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794478" y="295736"/>
                  <a:ext cx="4031424" cy="6002080"/>
                </a:xfrm>
                <a:prstGeom prst="rect">
                  <a:avLst/>
                </a:prstGeom>
              </p:spPr>
            </p:pic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9D9E219C-8760-AA85-E283-7F5D2EBFC8DA}"/>
                    </a:ext>
                  </a:extLst>
                </p:cNvPr>
                <p:cNvSpPr txBox="1"/>
                <p:nvPr/>
              </p:nvSpPr>
              <p:spPr>
                <a:xfrm>
                  <a:off x="2433100" y="421419"/>
                  <a:ext cx="1502796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T No ABX</a:t>
                  </a:r>
                </a:p>
              </p:txBody>
            </p:sp>
          </p:grp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3B3C073A-16CE-79E3-4326-91115886D5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78386" y="1725433"/>
                <a:ext cx="0" cy="3912042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0E16FB3-5B9B-EB86-B1D7-440F396DC770}"/>
                </a:ext>
              </a:extLst>
            </p:cNvPr>
            <p:cNvSpPr txBox="1"/>
            <p:nvPr/>
          </p:nvSpPr>
          <p:spPr>
            <a:xfrm>
              <a:off x="485030" y="492981"/>
              <a:ext cx="216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B065277-C7E6-7CB6-F903-29EDA59BE524}"/>
              </a:ext>
            </a:extLst>
          </p:cNvPr>
          <p:cNvGrpSpPr/>
          <p:nvPr/>
        </p:nvGrpSpPr>
        <p:grpSpPr>
          <a:xfrm>
            <a:off x="4769590" y="295736"/>
            <a:ext cx="6888918" cy="4339449"/>
            <a:chOff x="4769590" y="295736"/>
            <a:chExt cx="6888918" cy="4339449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B6ABAC79-81AC-DAE7-0C48-2C8D0056F825}"/>
                </a:ext>
              </a:extLst>
            </p:cNvPr>
            <p:cNvGrpSpPr/>
            <p:nvPr/>
          </p:nvGrpSpPr>
          <p:grpSpPr>
            <a:xfrm>
              <a:off x="4918679" y="295736"/>
              <a:ext cx="6739829" cy="4339449"/>
              <a:chOff x="4918679" y="295736"/>
              <a:chExt cx="6739829" cy="4339449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07316E39-9B53-613C-6D36-912E439D92A0}"/>
                  </a:ext>
                </a:extLst>
              </p:cNvPr>
              <p:cNvGrpSpPr/>
              <p:nvPr/>
            </p:nvGrpSpPr>
            <p:grpSpPr>
              <a:xfrm>
                <a:off x="4918679" y="295736"/>
                <a:ext cx="6739829" cy="4339449"/>
                <a:chOff x="4918679" y="295736"/>
                <a:chExt cx="6739829" cy="4339449"/>
              </a:xfrm>
            </p:grpSpPr>
            <p:pic>
              <p:nvPicPr>
                <p:cNvPr id="10" name="Picture 9" descr="A screenshot of a graph&#10;&#10;AI-generated content may be incorrect.">
                  <a:extLst>
                    <a:ext uri="{FF2B5EF4-FFF2-40B4-BE49-F238E27FC236}">
                      <a16:creationId xmlns:a16="http://schemas.microsoft.com/office/drawing/2014/main" id="{2BF3E76F-EF2F-C0C5-A913-C84EFF9A2EC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918679" y="295736"/>
                  <a:ext cx="6739829" cy="4339449"/>
                </a:xfrm>
                <a:prstGeom prst="rect">
                  <a:avLst/>
                </a:prstGeom>
              </p:spPr>
            </p:pic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C259CF27-CB75-AFC6-65B1-3A872A90EDEE}"/>
                    </a:ext>
                  </a:extLst>
                </p:cNvPr>
                <p:cNvSpPr txBox="1"/>
                <p:nvPr/>
              </p:nvSpPr>
              <p:spPr>
                <a:xfrm>
                  <a:off x="7928775" y="421418"/>
                  <a:ext cx="1684351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T Post-ABX</a:t>
                  </a:r>
                </a:p>
              </p:txBody>
            </p:sp>
          </p:grp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006648BD-6D9D-89BF-931E-D3DA8817FF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62999" y="1264257"/>
                <a:ext cx="0" cy="2703444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9FD8421-CAA3-D9D2-9FC8-8D7F49070B68}"/>
                </a:ext>
              </a:extLst>
            </p:cNvPr>
            <p:cNvSpPr txBox="1"/>
            <p:nvPr/>
          </p:nvSpPr>
          <p:spPr>
            <a:xfrm>
              <a:off x="4769590" y="506881"/>
              <a:ext cx="216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3A0CDD40-FE8A-0250-7952-5675684587A2}"/>
              </a:ext>
            </a:extLst>
          </p:cNvPr>
          <p:cNvSpPr txBox="1"/>
          <p:nvPr/>
        </p:nvSpPr>
        <p:spPr>
          <a:xfrm>
            <a:off x="1594884" y="6145612"/>
            <a:ext cx="9260958" cy="2643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1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 2 </a:t>
            </a:r>
            <a:r>
              <a:rPr lang="en-US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 maps show fold changes in metabolites identified as significantly different in BAT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7891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C61256E-6AC3-3293-88F8-243C014018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CA25B406-73F3-AE4D-FBED-F3734E27F1E4}"/>
              </a:ext>
            </a:extLst>
          </p:cNvPr>
          <p:cNvGrpSpPr/>
          <p:nvPr/>
        </p:nvGrpSpPr>
        <p:grpSpPr>
          <a:xfrm>
            <a:off x="101196" y="872689"/>
            <a:ext cx="5737629" cy="3813611"/>
            <a:chOff x="40677" y="97871"/>
            <a:chExt cx="6931459" cy="4462831"/>
          </a:xfrm>
        </p:grpSpPr>
        <p:pic>
          <p:nvPicPr>
            <p:cNvPr id="3" name="Picture 2" descr="A screenshot of a graph&#10;&#10;AI-generated content may be incorrect.">
              <a:extLst>
                <a:ext uri="{FF2B5EF4-FFF2-40B4-BE49-F238E27FC236}">
                  <a16:creationId xmlns:a16="http://schemas.microsoft.com/office/drawing/2014/main" id="{2CA3F32A-E4CA-F6EE-1669-134EEAA380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677" y="97871"/>
              <a:ext cx="6931459" cy="4462831"/>
            </a:xfrm>
            <a:prstGeom prst="rect">
              <a:avLst/>
            </a:prstGeom>
          </p:spPr>
        </p:pic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4631BF8-B619-07DA-29C2-F239B5B9AA4F}"/>
                </a:ext>
              </a:extLst>
            </p:cNvPr>
            <p:cNvGrpSpPr/>
            <p:nvPr/>
          </p:nvGrpSpPr>
          <p:grpSpPr>
            <a:xfrm>
              <a:off x="48385" y="97871"/>
              <a:ext cx="4900476" cy="3616879"/>
              <a:chOff x="218503" y="421419"/>
              <a:chExt cx="4900476" cy="3616879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CE0D6521-AA34-0506-88F4-F8C90EE305E1}"/>
                  </a:ext>
                </a:extLst>
              </p:cNvPr>
              <p:cNvGrpSpPr/>
              <p:nvPr/>
            </p:nvGrpSpPr>
            <p:grpSpPr>
              <a:xfrm>
                <a:off x="2867111" y="559918"/>
                <a:ext cx="2251868" cy="3478380"/>
                <a:chOff x="2867111" y="559918"/>
                <a:chExt cx="2251868" cy="3478380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08467D29-3B12-4F50-3A75-2BA9F051F6AC}"/>
                    </a:ext>
                  </a:extLst>
                </p:cNvPr>
                <p:cNvSpPr txBox="1"/>
                <p:nvPr/>
              </p:nvSpPr>
              <p:spPr>
                <a:xfrm>
                  <a:off x="2867111" y="559918"/>
                  <a:ext cx="2251868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Quadriceps No ABX</a:t>
                  </a:r>
                </a:p>
              </p:txBody>
            </p: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775DFFBB-FFF0-0E8B-A241-2A6577004F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16611" y="1523698"/>
                  <a:ext cx="0" cy="25146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AA88671-2ABF-904A-27B9-B38CBDA48A5C}"/>
                  </a:ext>
                </a:extLst>
              </p:cNvPr>
              <p:cNvSpPr txBox="1"/>
              <p:nvPr/>
            </p:nvSpPr>
            <p:spPr>
              <a:xfrm>
                <a:off x="218503" y="421419"/>
                <a:ext cx="2166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43DFAFA-A8AC-F414-E45D-A8C91B686F81}"/>
              </a:ext>
            </a:extLst>
          </p:cNvPr>
          <p:cNvGrpSpPr/>
          <p:nvPr/>
        </p:nvGrpSpPr>
        <p:grpSpPr>
          <a:xfrm>
            <a:off x="6137418" y="891739"/>
            <a:ext cx="5737629" cy="3696362"/>
            <a:chOff x="6468318" y="68626"/>
            <a:chExt cx="6847520" cy="4408786"/>
          </a:xfrm>
        </p:grpSpPr>
        <p:pic>
          <p:nvPicPr>
            <p:cNvPr id="5" name="Picture 4" descr="A screenshot of a graph&#10;&#10;AI-generated content may be incorrect.">
              <a:extLst>
                <a:ext uri="{FF2B5EF4-FFF2-40B4-BE49-F238E27FC236}">
                  <a16:creationId xmlns:a16="http://schemas.microsoft.com/office/drawing/2014/main" id="{8C93AAB2-026A-66E5-3903-035315D5E07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68318" y="68626"/>
              <a:ext cx="6847520" cy="4408786"/>
            </a:xfrm>
            <a:prstGeom prst="rect">
              <a:avLst/>
            </a:prstGeom>
          </p:spPr>
        </p:pic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D851298B-2C99-7EAB-BB2E-4508BDD0D9EC}"/>
                </a:ext>
              </a:extLst>
            </p:cNvPr>
            <p:cNvGrpSpPr/>
            <p:nvPr/>
          </p:nvGrpSpPr>
          <p:grpSpPr>
            <a:xfrm>
              <a:off x="6468318" y="86489"/>
              <a:ext cx="5543390" cy="3610951"/>
              <a:chOff x="3658443" y="61475"/>
              <a:chExt cx="5543390" cy="3610951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9C6AB530-FF1C-8B62-C085-57CCB49BFD6E}"/>
                  </a:ext>
                </a:extLst>
              </p:cNvPr>
              <p:cNvGrpSpPr/>
              <p:nvPr/>
            </p:nvGrpSpPr>
            <p:grpSpPr>
              <a:xfrm>
                <a:off x="6681000" y="162052"/>
                <a:ext cx="2520833" cy="3510374"/>
                <a:chOff x="6681000" y="162052"/>
                <a:chExt cx="2520833" cy="3510374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99406A59-876E-716B-EB5E-91D5F2AD1F0A}"/>
                    </a:ext>
                  </a:extLst>
                </p:cNvPr>
                <p:cNvSpPr txBox="1"/>
                <p:nvPr/>
              </p:nvSpPr>
              <p:spPr>
                <a:xfrm>
                  <a:off x="6681000" y="162052"/>
                  <a:ext cx="2520833" cy="36709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Quadriceps Post-ABX</a:t>
                  </a:r>
                </a:p>
              </p:txBody>
            </p: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9D61A49D-42CF-05B6-8B25-2E729F6199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62849" y="1089411"/>
                  <a:ext cx="0" cy="258301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41C8ED74-D17A-E1AC-8025-F80D14973B66}"/>
                  </a:ext>
                </a:extLst>
              </p:cNvPr>
              <p:cNvSpPr txBox="1"/>
              <p:nvPr/>
            </p:nvSpPr>
            <p:spPr>
              <a:xfrm>
                <a:off x="3658443" y="61475"/>
                <a:ext cx="2166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6DE92ED8-A592-F77F-EAB9-985541D04CBC}"/>
              </a:ext>
            </a:extLst>
          </p:cNvPr>
          <p:cNvSpPr txBox="1"/>
          <p:nvPr/>
        </p:nvSpPr>
        <p:spPr>
          <a:xfrm>
            <a:off x="1357197" y="5167540"/>
            <a:ext cx="9560441" cy="2643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1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 3 </a:t>
            </a:r>
            <a:r>
              <a:rPr lang="en-US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 maps show fold changes in metabolites identified as significantly different in the quadriceps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98114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94DB8DB-8BDA-383B-0A28-DFBB58435B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2552" y="214008"/>
            <a:ext cx="6409746" cy="593160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F8134B9-ADE9-7449-8FEB-0143BEC4355D}"/>
              </a:ext>
            </a:extLst>
          </p:cNvPr>
          <p:cNvSpPr txBox="1"/>
          <p:nvPr/>
        </p:nvSpPr>
        <p:spPr>
          <a:xfrm>
            <a:off x="1594884" y="5912148"/>
            <a:ext cx="9260958" cy="626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1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Table 1 Plasma Analyte Concentrations. </a:t>
            </a:r>
            <a:r>
              <a:rPr lang="en-US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feron gamma (IFN-ᵧ), interleukin (IL), Lipopolysaccharide-induced C-X-C motif chemokine (LIX), Interferon-ᵧ inducible protein 10 (IP-10), monocyte chemoattractant protein-1 (MCP-1), macrophage inflammatory protein-2 (MIP-2), tumor necrosis factor-α (TNF-α), vascular endothelial growth factor (VEGF). Data shown as mean analyte values (pg/μL)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± </a:t>
            </a:r>
            <a:r>
              <a:rPr lang="en-US" sz="11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ndard error of the mean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36771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D3F4A8B0-E82E-98B5-D70A-0F93D2844529}"/>
              </a:ext>
            </a:extLst>
          </p:cNvPr>
          <p:cNvGrpSpPr/>
          <p:nvPr/>
        </p:nvGrpSpPr>
        <p:grpSpPr>
          <a:xfrm>
            <a:off x="2898388" y="241551"/>
            <a:ext cx="5862837" cy="5184051"/>
            <a:chOff x="3554011" y="1481851"/>
            <a:chExt cx="5862837" cy="5184051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C448756-E01E-1244-BA3D-CC1967817A28}"/>
                </a:ext>
              </a:extLst>
            </p:cNvPr>
            <p:cNvGrpSpPr/>
            <p:nvPr/>
          </p:nvGrpSpPr>
          <p:grpSpPr>
            <a:xfrm>
              <a:off x="3554011" y="1683699"/>
              <a:ext cx="5862837" cy="4982203"/>
              <a:chOff x="246607" y="862130"/>
              <a:chExt cx="5862837" cy="4982203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97DF132-0B7A-CFC2-08D3-C99F844AC8E8}"/>
                  </a:ext>
                </a:extLst>
              </p:cNvPr>
              <p:cNvGrpSpPr/>
              <p:nvPr/>
            </p:nvGrpSpPr>
            <p:grpSpPr>
              <a:xfrm>
                <a:off x="246607" y="862130"/>
                <a:ext cx="4613962" cy="4982203"/>
                <a:chOff x="6609451" y="1629220"/>
                <a:chExt cx="4613962" cy="4982203"/>
              </a:xfrm>
            </p:grpSpPr>
            <p:grpSp>
              <p:nvGrpSpPr>
                <p:cNvPr id="23" name="Group 22">
                  <a:extLst>
                    <a:ext uri="{FF2B5EF4-FFF2-40B4-BE49-F238E27FC236}">
                      <a16:creationId xmlns:a16="http://schemas.microsoft.com/office/drawing/2014/main" id="{A0F12B66-6583-4D12-EE75-60131D8F2711}"/>
                    </a:ext>
                  </a:extLst>
                </p:cNvPr>
                <p:cNvGrpSpPr/>
                <p:nvPr/>
              </p:nvGrpSpPr>
              <p:grpSpPr>
                <a:xfrm>
                  <a:off x="6609451" y="1983567"/>
                  <a:ext cx="4613962" cy="4627856"/>
                  <a:chOff x="6609451" y="1983567"/>
                  <a:chExt cx="4613962" cy="4627856"/>
                </a:xfrm>
              </p:grpSpPr>
              <p:grpSp>
                <p:nvGrpSpPr>
                  <p:cNvPr id="25" name="Group 24">
                    <a:extLst>
                      <a:ext uri="{FF2B5EF4-FFF2-40B4-BE49-F238E27FC236}">
                        <a16:creationId xmlns:a16="http://schemas.microsoft.com/office/drawing/2014/main" id="{10DCD1DD-ED42-3A93-DBD3-ED45520028B2}"/>
                      </a:ext>
                    </a:extLst>
                  </p:cNvPr>
                  <p:cNvGrpSpPr/>
                  <p:nvPr/>
                </p:nvGrpSpPr>
                <p:grpSpPr>
                  <a:xfrm>
                    <a:off x="6609451" y="1983567"/>
                    <a:ext cx="4613962" cy="4627856"/>
                    <a:chOff x="6609451" y="1983567"/>
                    <a:chExt cx="4613962" cy="4627856"/>
                  </a:xfrm>
                </p:grpSpPr>
                <p:pic>
                  <p:nvPicPr>
                    <p:cNvPr id="27" name="Picture 26">
                      <a:extLst>
                        <a:ext uri="{FF2B5EF4-FFF2-40B4-BE49-F238E27FC236}">
                          <a16:creationId xmlns:a16="http://schemas.microsoft.com/office/drawing/2014/main" id="{2EDFF982-B0D9-CE9F-40B3-C6DA0A8F567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3016" t="6331" r="8095" b="4514"/>
                    <a:stretch/>
                  </p:blipFill>
                  <p:spPr>
                    <a:xfrm>
                      <a:off x="6609451" y="1983567"/>
                      <a:ext cx="4613962" cy="4627856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28" name="Straight Connector 27">
                      <a:extLst>
                        <a:ext uri="{FF2B5EF4-FFF2-40B4-BE49-F238E27FC236}">
                          <a16:creationId xmlns:a16="http://schemas.microsoft.com/office/drawing/2014/main" id="{9805E5FD-D555-99DC-2406-7F9C43696FC9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200113" y="2005339"/>
                      <a:ext cx="0" cy="500252"/>
                    </a:xfrm>
                    <a:prstGeom prst="line">
                      <a:avLst/>
                    </a:prstGeom>
                    <a:ln w="1905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6" name="Straight Connector 25">
                    <a:extLst>
                      <a:ext uri="{FF2B5EF4-FFF2-40B4-BE49-F238E27FC236}">
                        <a16:creationId xmlns:a16="http://schemas.microsoft.com/office/drawing/2014/main" id="{78A77579-9129-F87B-2053-8ED18D93F26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7119257" y="2002975"/>
                    <a:ext cx="80055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3AAA838A-2BB1-665E-ECF8-AA7B1B40DC1C}"/>
                    </a:ext>
                  </a:extLst>
                </p:cNvPr>
                <p:cNvSpPr txBox="1"/>
                <p:nvPr/>
              </p:nvSpPr>
              <p:spPr>
                <a:xfrm rot="16200000">
                  <a:off x="6717945" y="1775354"/>
                  <a:ext cx="5384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 Nova Cond" panose="020B0604020202020204" pitchFamily="34" charset="0"/>
                    </a:rPr>
                    <a:t>4.0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F78A86B2-FAF9-05CD-D512-9A4D2AFB965F}"/>
                  </a:ext>
                </a:extLst>
              </p:cNvPr>
              <p:cNvGrpSpPr/>
              <p:nvPr/>
            </p:nvGrpSpPr>
            <p:grpSpPr>
              <a:xfrm>
                <a:off x="1046798" y="1173035"/>
                <a:ext cx="5062646" cy="3462384"/>
                <a:chOff x="1112112" y="1167555"/>
                <a:chExt cx="5062646" cy="3462384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F81B215A-0619-37D7-1BEA-A7D3807B673E}"/>
                    </a:ext>
                  </a:extLst>
                </p:cNvPr>
                <p:cNvSpPr txBox="1"/>
                <p:nvPr/>
              </p:nvSpPr>
              <p:spPr>
                <a:xfrm>
                  <a:off x="2000800" y="1167555"/>
                  <a:ext cx="151638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urine metabolism*</a:t>
                  </a:r>
                </a:p>
              </p:txBody>
            </p: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C7A2F23A-6EFA-5D2A-F602-BCC426A6D6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790376" y="1290666"/>
                  <a:ext cx="210424" cy="47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53763313-D2E0-E049-503A-58E2045B4A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115622" y="2421699"/>
                  <a:ext cx="90816" cy="10991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0C6ECCA2-84FF-B94A-7A08-7F09025165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112112" y="3220436"/>
                  <a:ext cx="210424" cy="47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id="{F511D1DF-9A6D-B6C1-D960-41A3582A5A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95842" y="2487675"/>
                  <a:ext cx="0" cy="33752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F96EA7FB-7814-9FC5-11F3-823B8255EA88}"/>
                    </a:ext>
                  </a:extLst>
                </p:cNvPr>
                <p:cNvSpPr txBox="1"/>
                <p:nvPr/>
              </p:nvSpPr>
              <p:spPr>
                <a:xfrm>
                  <a:off x="1179010" y="2131506"/>
                  <a:ext cx="251682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line, leucine, and isoleucine biosynthesis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D0F3F80D-C73E-2D20-B6A6-8FE1C5AEF181}"/>
                    </a:ext>
                  </a:extLst>
                </p:cNvPr>
                <p:cNvSpPr txBox="1"/>
                <p:nvPr/>
              </p:nvSpPr>
              <p:spPr>
                <a:xfrm>
                  <a:off x="1276587" y="3091027"/>
                  <a:ext cx="228897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inoacyl-tRNA biosynthesis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3AFF2068-8BF0-D1D2-7BF5-E8669787974C}"/>
                    </a:ext>
                  </a:extLst>
                </p:cNvPr>
                <p:cNvSpPr txBox="1"/>
                <p:nvPr/>
              </p:nvSpPr>
              <p:spPr>
                <a:xfrm>
                  <a:off x="3517188" y="2299639"/>
                  <a:ext cx="228897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henylalanine metabolism</a:t>
                  </a:r>
                </a:p>
              </p:txBody>
            </p: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8E3A8CE0-8C23-37CF-DDE0-F757C610C1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49878" y="4171010"/>
                  <a:ext cx="0" cy="19709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7AF7DA37-19A9-ACC0-CB70-AA8B10844AD6}"/>
                    </a:ext>
                  </a:extLst>
                </p:cNvPr>
                <p:cNvSpPr txBox="1"/>
                <p:nvPr/>
              </p:nvSpPr>
              <p:spPr>
                <a:xfrm>
                  <a:off x="2655387" y="4383718"/>
                  <a:ext cx="35193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henylalanine, tyrosine, and tryptophan biosynthesis</a:t>
                  </a:r>
                </a:p>
              </p:txBody>
            </p: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93EF3415-D502-51F5-AD1C-FD1D01AB613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130218" y="4118060"/>
                  <a:ext cx="210424" cy="47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977DE5CE-C4DC-3CEA-7B89-AC459658B81E}"/>
                    </a:ext>
                  </a:extLst>
                </p:cNvPr>
                <p:cNvSpPr txBox="1"/>
                <p:nvPr/>
              </p:nvSpPr>
              <p:spPr>
                <a:xfrm>
                  <a:off x="1322536" y="3992513"/>
                  <a:ext cx="273426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line, leucine, and isoleucine degradation</a:t>
                  </a:r>
                </a:p>
              </p:txBody>
            </p:sp>
          </p:grp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D1150ADB-19B6-D6F7-B216-DD40B9B15B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14638" y="3595427"/>
                <a:ext cx="210424" cy="476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7C19677-F2C2-174A-DDFA-5957A0A654A0}"/>
                  </a:ext>
                </a:extLst>
              </p:cNvPr>
              <p:cNvSpPr txBox="1"/>
              <p:nvPr/>
            </p:nvSpPr>
            <p:spPr>
              <a:xfrm>
                <a:off x="1656955" y="3465373"/>
                <a:ext cx="22889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entose phosphate pathway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A209090-230B-DAD7-2C6B-E6FB9381C4EE}"/>
                </a:ext>
              </a:extLst>
            </p:cNvPr>
            <p:cNvSpPr txBox="1"/>
            <p:nvPr/>
          </p:nvSpPr>
          <p:spPr>
            <a:xfrm>
              <a:off x="3808639" y="1481851"/>
              <a:ext cx="49876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GS14 KO Quadriceps Metabolite Pathways before ABX </a:t>
              </a:r>
            </a:p>
          </p:txBody>
        </p:sp>
      </p:grpSp>
      <p:sp>
        <p:nvSpPr>
          <p:cNvPr id="31" name="Text Box 2">
            <a:extLst>
              <a:ext uri="{FF2B5EF4-FFF2-40B4-BE49-F238E27FC236}">
                <a16:creationId xmlns:a16="http://schemas.microsoft.com/office/drawing/2014/main" id="{F74F12A9-1A12-64B1-FCF1-730771EC7E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1710" y="5563919"/>
            <a:ext cx="10006387" cy="57941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pological metabolite pathway analysis of quadriceps using MetaboAnalyst 6.0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ignificant metabolic pathway identified in quadriceps before ABX treatment from metabolites of significantly higher concentrations in RGS14 KO mice. *: p&lt;0.05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19791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E942CCE-DA66-5A4B-94F2-659CF4DBD954}"/>
              </a:ext>
            </a:extLst>
          </p:cNvPr>
          <p:cNvSpPr txBox="1"/>
          <p:nvPr/>
        </p:nvSpPr>
        <p:spPr>
          <a:xfrm>
            <a:off x="1233557" y="6203141"/>
            <a:ext cx="10068210" cy="264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 5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 of the dominant bacterial phyla in fecal samples of the RGS14 KO and WT mice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A graph of different colored bars&#10;&#10;AI-generated content may be incorrect.">
            <a:extLst>
              <a:ext uri="{FF2B5EF4-FFF2-40B4-BE49-F238E27FC236}">
                <a16:creationId xmlns:a16="http://schemas.microsoft.com/office/drawing/2014/main" id="{B930B65C-83DF-DC1E-D7EB-61D5687B64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5776" y="271179"/>
            <a:ext cx="9753600" cy="5724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68312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458693-75DD-8048-97C6-16425A85DB08}"/>
              </a:ext>
            </a:extLst>
          </p:cNvPr>
          <p:cNvSpPr txBox="1"/>
          <p:nvPr/>
        </p:nvSpPr>
        <p:spPr>
          <a:xfrm>
            <a:off x="1346228" y="6309639"/>
            <a:ext cx="11301058" cy="264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 6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 of the top 10 bacterial classes in fecal samples of the RGS14 KO and WT mice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graph showing different colored bars&#10;&#10;AI-generated content may be incorrect.">
            <a:extLst>
              <a:ext uri="{FF2B5EF4-FFF2-40B4-BE49-F238E27FC236}">
                <a16:creationId xmlns:a16="http://schemas.microsoft.com/office/drawing/2014/main" id="{4936D44C-44FE-52ED-6427-02ECC6E8A4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2636" y="589107"/>
            <a:ext cx="10460613" cy="5679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2143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F940BA-34AD-12DA-E767-DBEC69ECAC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1E6A735-E78D-5C1E-1B4D-F02D3EC0C5BB}"/>
              </a:ext>
            </a:extLst>
          </p:cNvPr>
          <p:cNvSpPr txBox="1"/>
          <p:nvPr/>
        </p:nvSpPr>
        <p:spPr>
          <a:xfrm>
            <a:off x="1203324" y="6294793"/>
            <a:ext cx="10887076" cy="264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7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 of the top 10 bacterial orders in fecal samples of the RGS14 KO and WT mice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graph showing different levels of classification&#10;&#10;AI-generated content may be incorrect.">
            <a:extLst>
              <a:ext uri="{FF2B5EF4-FFF2-40B4-BE49-F238E27FC236}">
                <a16:creationId xmlns:a16="http://schemas.microsoft.com/office/drawing/2014/main" id="{1BE92D5B-BAB0-E08B-BF25-E82C04FEB5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3324" y="464565"/>
            <a:ext cx="9753600" cy="5762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9132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083</TotalTime>
  <Words>812</Words>
  <Application>Microsoft Office PowerPoint</Application>
  <PresentationFormat>Widescreen</PresentationFormat>
  <Paragraphs>52</Paragraphs>
  <Slides>1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Arial</vt:lpstr>
      <vt:lpstr>Arial Nova Cond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nmi Ibironke</dc:creator>
  <cp:lastModifiedBy>Sara Campbell</cp:lastModifiedBy>
  <cp:revision>89</cp:revision>
  <dcterms:created xsi:type="dcterms:W3CDTF">2021-05-12T19:14:44Z</dcterms:created>
  <dcterms:modified xsi:type="dcterms:W3CDTF">2026-02-23T21:53:31Z</dcterms:modified>
</cp:coreProperties>
</file>